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62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9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12304;&#22519;&#31558;&#20013;&#12305;_&#12512;&#12463;&#12490;&#35910;%20&#29976;&#37202;\&#12304;&#25237;&#31295;&#12305;Food%20bioscience\&#12304;&#31532;1&#22577;&#12305;Tables%20&amp;%20Figur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281818533020963"/>
          <c:y val="4.7709006993358935E-2"/>
          <c:w val="0.72690650430060344"/>
          <c:h val="0.676916312648466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911-4092-A993-2EF9DF8D952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911-4092-A993-2EF9DF8D952A}"/>
              </c:ext>
            </c:extLst>
          </c:dPt>
          <c:dPt>
            <c:idx val="2"/>
            <c:invertIfNegative val="0"/>
            <c:bubble3D val="0"/>
            <c:spPr>
              <a:pattFill prst="pct25">
                <a:fgClr>
                  <a:schemeClr val="tx1">
                    <a:lumMod val="65000"/>
                    <a:lumOff val="3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911-4092-A993-2EF9DF8D952A}"/>
              </c:ext>
            </c:extLst>
          </c:dPt>
          <c:dPt>
            <c:idx val="3"/>
            <c:invertIfNegative val="0"/>
            <c:bubble3D val="0"/>
            <c:spPr>
              <a:pattFill prst="pct25">
                <a:fgClr>
                  <a:schemeClr val="tx1">
                    <a:lumMod val="65000"/>
                    <a:lumOff val="3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911-4092-A993-2EF9DF8D952A}"/>
              </c:ext>
            </c:extLst>
          </c:dPt>
          <c:errBars>
            <c:errBarType val="both"/>
            <c:errValType val="cust"/>
            <c:noEndCap val="0"/>
            <c:plus>
              <c:numRef>
                <c:f>'α-アミラーゼ活性'!$J$33:$J$36</c:f>
                <c:numCache>
                  <c:formatCode>General</c:formatCode>
                  <c:ptCount val="4"/>
                  <c:pt idx="0">
                    <c:v>8.7635609200826664E-3</c:v>
                  </c:pt>
                  <c:pt idx="1">
                    <c:v>9.311283477587801E-3</c:v>
                  </c:pt>
                  <c:pt idx="2">
                    <c:v>1.6431676725154997E-3</c:v>
                  </c:pt>
                  <c:pt idx="3">
                    <c:v>6.5726706900619989E-3</c:v>
                  </c:pt>
                </c:numCache>
              </c:numRef>
            </c:plus>
            <c:minus>
              <c:numRef>
                <c:f>'α-アミラーゼ活性'!$J$33:$J$36</c:f>
                <c:numCache>
                  <c:formatCode>General</c:formatCode>
                  <c:ptCount val="4"/>
                  <c:pt idx="0">
                    <c:v>8.7635609200826664E-3</c:v>
                  </c:pt>
                  <c:pt idx="1">
                    <c:v>9.311283477587801E-3</c:v>
                  </c:pt>
                  <c:pt idx="2">
                    <c:v>1.6431676725154997E-3</c:v>
                  </c:pt>
                  <c:pt idx="3">
                    <c:v>6.572670690061998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α-アミラーゼ活性'!$B$33:$B$36</c:f>
              <c:strCache>
                <c:ptCount val="4"/>
                <c:pt idx="0">
                  <c:v>RA 0h</c:v>
                </c:pt>
                <c:pt idx="1">
                  <c:v>RA 8h</c:v>
                </c:pt>
                <c:pt idx="2">
                  <c:v>MBA 0h</c:v>
                </c:pt>
                <c:pt idx="3">
                  <c:v>MBA 8h</c:v>
                </c:pt>
              </c:strCache>
            </c:strRef>
          </c:cat>
          <c:val>
            <c:numRef>
              <c:f>'α-アミラーゼ活性'!$I$33:$I$36</c:f>
              <c:numCache>
                <c:formatCode>General</c:formatCode>
                <c:ptCount val="4"/>
                <c:pt idx="0">
                  <c:v>0.34134999999999999</c:v>
                </c:pt>
                <c:pt idx="1">
                  <c:v>0.27709999999999996</c:v>
                </c:pt>
                <c:pt idx="2">
                  <c:v>0.33019999999999999</c:v>
                </c:pt>
                <c:pt idx="3">
                  <c:v>0.397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911-4092-A993-2EF9DF8D95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0"/>
        <c:overlap val="-55"/>
        <c:axId val="1394389199"/>
        <c:axId val="1394383439"/>
      </c:barChart>
      <c:catAx>
        <c:axId val="13943891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394383439"/>
        <c:crosses val="autoZero"/>
        <c:auto val="1"/>
        <c:lblAlgn val="ctr"/>
        <c:lblOffset val="100"/>
        <c:noMultiLvlLbl val="0"/>
      </c:catAx>
      <c:valAx>
        <c:axId val="1394383439"/>
        <c:scaling>
          <c:orientation val="minMax"/>
          <c:max val="0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‐Amylase activity</a:t>
                </a:r>
                <a:r>
                  <a:rPr lang="ja-JP" altLang="en-US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U/mL)</a:t>
                </a:r>
              </a:p>
            </c:rich>
          </c:tx>
          <c:layout>
            <c:manualLayout>
              <c:xMode val="edge"/>
              <c:yMode val="edge"/>
              <c:x val="6.2109512699578547E-2"/>
              <c:y val="9.050920466208940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394389199"/>
        <c:crosses val="autoZero"/>
        <c:crossBetween val="between"/>
        <c:majorUnit val="0.1"/>
      </c:valAx>
      <c:spPr>
        <a:solidFill>
          <a:schemeClr val="bg1"/>
        </a:solidFill>
        <a:ln w="952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DAC4CF-C285-46A9-AD64-89BACB3B9E0A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11B92B-DE61-4EE2-8794-B69AF85352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3489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11B92B-DE61-4EE2-8794-B69AF853524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8505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DE00DF-A8E6-B6FC-BD1C-92F74348C1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86B73BB-07FC-0516-146E-DF9310F1A3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276AF9C-8E6E-29A8-0264-F04FB3C29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AE4CD0-0F28-623F-AE1D-81B3CDFC9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A4F1D5-FD56-329E-4438-BBEE9D9D9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72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A8E9A5-6B0A-9EB4-A830-EB781B98B6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8B8CA82-635A-E590-EA2C-9C912DAF1E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072A87-FA9F-91C4-703C-F8802D576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C63CC3-7BCD-1E1E-619B-A2427406E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2D0C6F-C1C1-670D-3B15-6AC76EE96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499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BA6E01F-2B27-359C-897A-971B050BEC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5C74A8-2AA2-D238-4EA5-35168BDCE2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973818-4409-D1D1-B765-10B6EAD93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76500E-7C45-5612-E040-AB6F80EED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523819-5641-7CCB-C7DB-2244BF7B9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6166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FE8C28-5F54-D1A3-2C92-0FC3CAFC8B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DFD10C-085F-29DB-8340-7AE36D336C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21C77AE-7F44-B85D-6D20-B2949E08A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DB3705-8186-C72D-0D92-F7C398F99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822BF7-C320-0F07-7719-57F3B0B1E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5965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EB5DB8-BFFB-2C6D-0D78-5DF7A9F837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C806DF6-FBE3-20FA-6EB2-3D69AE8DA0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A82C71-EF69-1213-513B-9D1F81FA1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FF9B4A-696A-EDAB-AC52-DF2BAF7EF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86DA767-6CF4-9A67-FF11-7B238228C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6047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5B75E8-34E3-2033-C3F2-525947A1C8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F6B2CD0-4E3E-0D8E-F99E-4718C47BAB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DBA58D6-0980-4B54-F5AD-AA88B686F7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13339DC-5B95-6B0D-3221-37EDD320E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689A9D-4607-EEC1-FC7F-50FCB0680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5E5AA30-48E3-3E07-8003-2CA99F65F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865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DE358D-4EE5-41B8-6D92-BE775BEB26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D0BD896-44BF-9E2A-782F-ED5DF6A335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65A6CEC-AE9E-AEE9-40B5-F17B1EA502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D6CB929-003D-A95F-0481-0D766DB6BB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78B7482-37B2-BA5B-8633-CF6408CFE9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3E98B4B-C49B-3ABC-3448-4EE93477B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AD460ED-E1E4-5B43-FA2E-04984BBE1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4F0FBB7-9943-8DCE-10D4-58B1D5592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8246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DF0BB9-9B84-537F-323A-8C4F7832FD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F88C111-4678-1D60-B761-7691D95AE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F5777D6-B88B-826F-0DAF-3D72416FC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75850D0-B6A7-C5EE-8FA2-0228E96F3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650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AB315B1-095C-3CE3-8169-800B92148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2CD1AE4-2D18-3A90-C79B-1403B601F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8117D64-E00F-AA90-2166-ADD5CF216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7722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D9459C-46F6-49E4-297F-C8DD29BCEA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FE28F07-7B47-2FE4-BCCB-07AC6855F5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4E64473-5169-B91B-DBD2-E053356C14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D9CBD64-8F61-2215-AC4E-7038C4FFD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111EF4C-4552-0D12-8FF2-40B0C7D6B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50FF44-FE33-89D7-EE0C-B89A5878C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088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4118B6-6E62-F64B-269D-2E478D19F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54248B7-26BB-789A-EFDC-0311C2F647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1E96803-8800-A1B4-488A-78FD4C50C2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0C8A152-C8D0-9116-7F8B-A8DF307CE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BFEC917-25C3-E838-DF1A-EE551D9B97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C77E475-1576-2CB1-2383-F52320925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147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B3270D0-D4EC-6D5D-9DA2-D17EB1B383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9456AC9-D37A-D4C8-966C-39FB0EDA7C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DF2F3DE-87C8-6891-007E-047D3B9239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4978B4-2D49-471A-BB8A-8598AABEB260}" type="datetimeFigureOut">
              <a:rPr kumimoji="1" lang="ja-JP" altLang="en-US" smtClean="0"/>
              <a:t>2026/4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4A0D8E-C9F8-B9E7-B254-27ED0123A5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EF8C90-F70A-6D7B-BB32-4C44B4EC33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A87D739-36F4-4002-B8B7-B623638792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503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4426ECE-40B6-A96C-3E18-9D7E6ABA3C31}"/>
              </a:ext>
            </a:extLst>
          </p:cNvPr>
          <p:cNvSpPr txBox="1"/>
          <p:nvPr/>
        </p:nvSpPr>
        <p:spPr>
          <a:xfrm>
            <a:off x="2380508" y="5133349"/>
            <a:ext cx="7420063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HPLC chromatograms of amazake samples showing sugar fractions including low-DP sugars and higher-DP oligosaccharides (DP ≥ 4). (A)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totetraose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ndard solution; (B) Rice amazake before saccharification (RA, 0 h); (C) Rice amazake after saccharification (RA, 8 h); (D) Mucuna bean amazake before saccharification (MBA, 0 h); (E) Mucuna bean amazake after saccharification (MBA, 8 h).</a:t>
            </a:r>
          </a:p>
          <a:p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E70966A9-81F8-4260-523A-997E2738FB02}"/>
              </a:ext>
            </a:extLst>
          </p:cNvPr>
          <p:cNvGrpSpPr/>
          <p:nvPr/>
        </p:nvGrpSpPr>
        <p:grpSpPr>
          <a:xfrm>
            <a:off x="2353040" y="1100967"/>
            <a:ext cx="7354448" cy="3890827"/>
            <a:chOff x="2357437" y="459129"/>
            <a:chExt cx="7354448" cy="3890827"/>
          </a:xfrm>
        </p:grpSpPr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D33DB387-D225-9ADC-FE0C-FC08F5EFCB39}"/>
                </a:ext>
              </a:extLst>
            </p:cNvPr>
            <p:cNvGrpSpPr/>
            <p:nvPr/>
          </p:nvGrpSpPr>
          <p:grpSpPr>
            <a:xfrm>
              <a:off x="2357437" y="459129"/>
              <a:ext cx="7354448" cy="3868220"/>
              <a:chOff x="2357437" y="459129"/>
              <a:chExt cx="7354448" cy="3868220"/>
            </a:xfrm>
          </p:grpSpPr>
          <p:pic>
            <p:nvPicPr>
              <p:cNvPr id="7" name="図 6">
                <a:extLst>
                  <a:ext uri="{FF2B5EF4-FFF2-40B4-BE49-F238E27FC236}">
                    <a16:creationId xmlns:a16="http://schemas.microsoft.com/office/drawing/2014/main" id="{4D26DF43-1AD3-A53E-F6AE-A1186B6DE8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357437" y="481013"/>
                <a:ext cx="2389007" cy="1883816"/>
              </a:xfrm>
              <a:prstGeom prst="rect">
                <a:avLst/>
              </a:prstGeom>
            </p:spPr>
          </p:pic>
          <p:pic>
            <p:nvPicPr>
              <p:cNvPr id="9" name="図 8">
                <a:extLst>
                  <a:ext uri="{FF2B5EF4-FFF2-40B4-BE49-F238E27FC236}">
                    <a16:creationId xmlns:a16="http://schemas.microsoft.com/office/drawing/2014/main" id="{967B90D6-88B9-01CC-DBAE-BEE4E1FD64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839379" y="459129"/>
                <a:ext cx="2389007" cy="1905700"/>
              </a:xfrm>
              <a:prstGeom prst="rect">
                <a:avLst/>
              </a:prstGeom>
            </p:spPr>
          </p:pic>
          <p:pic>
            <p:nvPicPr>
              <p:cNvPr id="11" name="図 10">
                <a:extLst>
                  <a:ext uri="{FF2B5EF4-FFF2-40B4-BE49-F238E27FC236}">
                    <a16:creationId xmlns:a16="http://schemas.microsoft.com/office/drawing/2014/main" id="{D68AC46D-A75B-4C48-C1EB-753745CC41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839379" y="2421649"/>
                <a:ext cx="2362210" cy="1905700"/>
              </a:xfrm>
              <a:prstGeom prst="rect">
                <a:avLst/>
              </a:prstGeom>
            </p:spPr>
          </p:pic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F46445A4-1661-BB01-0E7F-33E28EB9B4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7321320" y="459129"/>
                <a:ext cx="2390565" cy="1905700"/>
              </a:xfrm>
              <a:prstGeom prst="rect">
                <a:avLst/>
              </a:prstGeom>
            </p:spPr>
          </p:pic>
          <p:pic>
            <p:nvPicPr>
              <p:cNvPr id="15" name="図 14">
                <a:extLst>
                  <a:ext uri="{FF2B5EF4-FFF2-40B4-BE49-F238E27FC236}">
                    <a16:creationId xmlns:a16="http://schemas.microsoft.com/office/drawing/2014/main" id="{BE52CC17-D679-9EBD-F46A-3561D4B241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321319" y="2421648"/>
                <a:ext cx="2389833" cy="1905699"/>
              </a:xfrm>
              <a:prstGeom prst="rect">
                <a:avLst/>
              </a:prstGeom>
            </p:spPr>
          </p:pic>
          <p:sp>
            <p:nvSpPr>
              <p:cNvPr id="16" name="テキスト ボックス 16">
                <a:extLst>
                  <a:ext uri="{FF2B5EF4-FFF2-40B4-BE49-F238E27FC236}">
                    <a16:creationId xmlns:a16="http://schemas.microsoft.com/office/drawing/2014/main" id="{5EBA638E-A06D-31B7-3B94-854C762D637C}"/>
                  </a:ext>
                </a:extLst>
              </p:cNvPr>
              <p:cNvSpPr txBox="1"/>
              <p:nvPr/>
            </p:nvSpPr>
            <p:spPr>
              <a:xfrm>
                <a:off x="2357437" y="481013"/>
                <a:ext cx="497776" cy="37465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)</a:t>
                </a:r>
                <a:endPara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56EC160C-4E4D-381D-F072-77C32F481089}"/>
                  </a:ext>
                </a:extLst>
              </p:cNvPr>
              <p:cNvSpPr txBox="1"/>
              <p:nvPr/>
            </p:nvSpPr>
            <p:spPr>
              <a:xfrm>
                <a:off x="4825531" y="470539"/>
                <a:ext cx="469681" cy="37465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)</a:t>
                </a:r>
                <a:endPara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テキスト ボックス 16">
                <a:extLst>
                  <a:ext uri="{FF2B5EF4-FFF2-40B4-BE49-F238E27FC236}">
                    <a16:creationId xmlns:a16="http://schemas.microsoft.com/office/drawing/2014/main" id="{5C0091EA-6885-FFCB-32D6-06686F96B603}"/>
                  </a:ext>
                </a:extLst>
              </p:cNvPr>
              <p:cNvSpPr txBox="1"/>
              <p:nvPr/>
            </p:nvSpPr>
            <p:spPr>
              <a:xfrm>
                <a:off x="7300348" y="472006"/>
                <a:ext cx="472051" cy="37465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)</a:t>
                </a:r>
                <a:endPara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テキスト ボックス 16">
                <a:extLst>
                  <a:ext uri="{FF2B5EF4-FFF2-40B4-BE49-F238E27FC236}">
                    <a16:creationId xmlns:a16="http://schemas.microsoft.com/office/drawing/2014/main" id="{1FC12826-03BF-2DB3-B369-C946DDE6F51F}"/>
                  </a:ext>
                </a:extLst>
              </p:cNvPr>
              <p:cNvSpPr txBox="1"/>
              <p:nvPr/>
            </p:nvSpPr>
            <p:spPr>
              <a:xfrm>
                <a:off x="4808756" y="2457050"/>
                <a:ext cx="491384" cy="37465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D)</a:t>
                </a:r>
                <a:endPara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テキスト ボックス 16">
                <a:extLst>
                  <a:ext uri="{FF2B5EF4-FFF2-40B4-BE49-F238E27FC236}">
                    <a16:creationId xmlns:a16="http://schemas.microsoft.com/office/drawing/2014/main" id="{580A0BC5-5247-659A-57EA-AB8FC5A4D5AA}"/>
                  </a:ext>
                </a:extLst>
              </p:cNvPr>
              <p:cNvSpPr txBox="1"/>
              <p:nvPr/>
            </p:nvSpPr>
            <p:spPr>
              <a:xfrm>
                <a:off x="7321318" y="2457050"/>
                <a:ext cx="484637" cy="37465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E)</a:t>
                </a:r>
                <a:endPara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5" name="テキスト ボックス 16">
              <a:extLst>
                <a:ext uri="{FF2B5EF4-FFF2-40B4-BE49-F238E27FC236}">
                  <a16:creationId xmlns:a16="http://schemas.microsoft.com/office/drawing/2014/main" id="{10396FBB-6DA5-71F0-150A-EA6BDE3961FA}"/>
                </a:ext>
              </a:extLst>
            </p:cNvPr>
            <p:cNvSpPr txBox="1"/>
            <p:nvPr/>
          </p:nvSpPr>
          <p:spPr>
            <a:xfrm>
              <a:off x="3281904" y="2242037"/>
              <a:ext cx="576857" cy="79131"/>
            </a:xfrm>
            <a:prstGeom prst="rect">
              <a:avLst/>
            </a:prstGeom>
            <a:solidFill>
              <a:schemeClr val="bg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16">
              <a:extLst>
                <a:ext uri="{FF2B5EF4-FFF2-40B4-BE49-F238E27FC236}">
                  <a16:creationId xmlns:a16="http://schemas.microsoft.com/office/drawing/2014/main" id="{637E602B-BFF5-5A82-A649-1865138C60DE}"/>
                </a:ext>
              </a:extLst>
            </p:cNvPr>
            <p:cNvSpPr txBox="1"/>
            <p:nvPr/>
          </p:nvSpPr>
          <p:spPr>
            <a:xfrm>
              <a:off x="3281903" y="2171696"/>
              <a:ext cx="576857" cy="21101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kumimoji="1" lang="en-US" altLang="ja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min)</a:t>
              </a:r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テキスト ボックス 16">
              <a:extLst>
                <a:ext uri="{FF2B5EF4-FFF2-40B4-BE49-F238E27FC236}">
                  <a16:creationId xmlns:a16="http://schemas.microsoft.com/office/drawing/2014/main" id="{5C2817F0-3EA5-51A0-4110-67AB35792C60}"/>
                </a:ext>
              </a:extLst>
            </p:cNvPr>
            <p:cNvSpPr txBox="1"/>
            <p:nvPr/>
          </p:nvSpPr>
          <p:spPr>
            <a:xfrm>
              <a:off x="5807571" y="2242037"/>
              <a:ext cx="576857" cy="79131"/>
            </a:xfrm>
            <a:prstGeom prst="rect">
              <a:avLst/>
            </a:prstGeom>
            <a:solidFill>
              <a:schemeClr val="bg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テキスト ボックス 16">
              <a:extLst>
                <a:ext uri="{FF2B5EF4-FFF2-40B4-BE49-F238E27FC236}">
                  <a16:creationId xmlns:a16="http://schemas.microsoft.com/office/drawing/2014/main" id="{8E0C4DDF-9714-0DBF-E299-CBA42AB92C1E}"/>
                </a:ext>
              </a:extLst>
            </p:cNvPr>
            <p:cNvSpPr txBox="1"/>
            <p:nvPr/>
          </p:nvSpPr>
          <p:spPr>
            <a:xfrm>
              <a:off x="5807571" y="2176094"/>
              <a:ext cx="576857" cy="21101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kumimoji="1" lang="en-US" altLang="ja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min)</a:t>
              </a:r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16">
              <a:extLst>
                <a:ext uri="{FF2B5EF4-FFF2-40B4-BE49-F238E27FC236}">
                  <a16:creationId xmlns:a16="http://schemas.microsoft.com/office/drawing/2014/main" id="{C3D711E1-3AB8-8B3E-E396-0C4274D4A3FB}"/>
                </a:ext>
              </a:extLst>
            </p:cNvPr>
            <p:cNvSpPr txBox="1"/>
            <p:nvPr/>
          </p:nvSpPr>
          <p:spPr>
            <a:xfrm>
              <a:off x="8289513" y="2242037"/>
              <a:ext cx="576857" cy="79131"/>
            </a:xfrm>
            <a:prstGeom prst="rect">
              <a:avLst/>
            </a:prstGeom>
            <a:solidFill>
              <a:schemeClr val="bg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16">
              <a:extLst>
                <a:ext uri="{FF2B5EF4-FFF2-40B4-BE49-F238E27FC236}">
                  <a16:creationId xmlns:a16="http://schemas.microsoft.com/office/drawing/2014/main" id="{ADA55C8E-162C-797B-443C-D8C96ABE2751}"/>
                </a:ext>
              </a:extLst>
            </p:cNvPr>
            <p:cNvSpPr txBox="1"/>
            <p:nvPr/>
          </p:nvSpPr>
          <p:spPr>
            <a:xfrm>
              <a:off x="8289513" y="2176094"/>
              <a:ext cx="576857" cy="21101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kumimoji="1" lang="en-US" altLang="ja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min)</a:t>
              </a:r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16">
              <a:extLst>
                <a:ext uri="{FF2B5EF4-FFF2-40B4-BE49-F238E27FC236}">
                  <a16:creationId xmlns:a16="http://schemas.microsoft.com/office/drawing/2014/main" id="{8C2620E3-D4B5-0AF9-01F6-DB6B04A90448}"/>
                </a:ext>
              </a:extLst>
            </p:cNvPr>
            <p:cNvSpPr txBox="1"/>
            <p:nvPr/>
          </p:nvSpPr>
          <p:spPr>
            <a:xfrm>
              <a:off x="5806509" y="4204883"/>
              <a:ext cx="576857" cy="79131"/>
            </a:xfrm>
            <a:prstGeom prst="rect">
              <a:avLst/>
            </a:prstGeom>
            <a:solidFill>
              <a:schemeClr val="bg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テキスト ボックス 16">
              <a:extLst>
                <a:ext uri="{FF2B5EF4-FFF2-40B4-BE49-F238E27FC236}">
                  <a16:creationId xmlns:a16="http://schemas.microsoft.com/office/drawing/2014/main" id="{5F6B11FA-BB6A-139D-D491-AA1C814402DD}"/>
                </a:ext>
              </a:extLst>
            </p:cNvPr>
            <p:cNvSpPr txBox="1"/>
            <p:nvPr/>
          </p:nvSpPr>
          <p:spPr>
            <a:xfrm>
              <a:off x="5806509" y="4138940"/>
              <a:ext cx="576857" cy="21101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kumimoji="1" lang="en-US" altLang="ja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min)</a:t>
              </a:r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テキスト ボックス 16">
              <a:extLst>
                <a:ext uri="{FF2B5EF4-FFF2-40B4-BE49-F238E27FC236}">
                  <a16:creationId xmlns:a16="http://schemas.microsoft.com/office/drawing/2014/main" id="{6AF13131-F83E-45F1-90B7-0614E18A2FF1}"/>
                </a:ext>
              </a:extLst>
            </p:cNvPr>
            <p:cNvSpPr txBox="1"/>
            <p:nvPr/>
          </p:nvSpPr>
          <p:spPr>
            <a:xfrm>
              <a:off x="8289513" y="4204883"/>
              <a:ext cx="576857" cy="79131"/>
            </a:xfrm>
            <a:prstGeom prst="rect">
              <a:avLst/>
            </a:prstGeom>
            <a:solidFill>
              <a:schemeClr val="bg1"/>
            </a:solidFill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16">
              <a:extLst>
                <a:ext uri="{FF2B5EF4-FFF2-40B4-BE49-F238E27FC236}">
                  <a16:creationId xmlns:a16="http://schemas.microsoft.com/office/drawing/2014/main" id="{276C31D3-B1B1-C22E-9296-A5A9656FD780}"/>
                </a:ext>
              </a:extLst>
            </p:cNvPr>
            <p:cNvSpPr txBox="1"/>
            <p:nvPr/>
          </p:nvSpPr>
          <p:spPr>
            <a:xfrm>
              <a:off x="8289513" y="4138940"/>
              <a:ext cx="576857" cy="21101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kumimoji="1" lang="en-US" altLang="ja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min)</a:t>
              </a:r>
              <a:endParaRPr kumimoji="1" lang="ja-JP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816731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C95020C-8219-C20A-627F-B0A2C44C3F36}"/>
              </a:ext>
            </a:extLst>
          </p:cNvPr>
          <p:cNvSpPr txBox="1"/>
          <p:nvPr/>
        </p:nvSpPr>
        <p:spPr>
          <a:xfrm>
            <a:off x="3048515" y="5264145"/>
            <a:ext cx="609497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.</a:t>
            </a:r>
            <a:b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l-GR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α-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ylase activity in rice amazake (RA) and Mucuna bean amazake (MBA) before (0 h) and after (8 h) saccharification. Values are presented as mean ± SD (n = 3). Different letters indicate significant differences among groups (Tukey’s test, p &lt; 0.05).</a:t>
            </a: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41F6180A-7561-48CE-BEB8-DB51A70184DC}"/>
              </a:ext>
            </a:extLst>
          </p:cNvPr>
          <p:cNvGrpSpPr/>
          <p:nvPr/>
        </p:nvGrpSpPr>
        <p:grpSpPr>
          <a:xfrm>
            <a:off x="4653491" y="2042583"/>
            <a:ext cx="2885017" cy="2772834"/>
            <a:chOff x="0" y="0"/>
            <a:chExt cx="2899128" cy="2736145"/>
          </a:xfrm>
        </p:grpSpPr>
        <p:graphicFrame>
          <p:nvGraphicFramePr>
            <p:cNvPr id="7" name="グラフ 6">
              <a:extLst>
                <a:ext uri="{FF2B5EF4-FFF2-40B4-BE49-F238E27FC236}">
                  <a16:creationId xmlns:a16="http://schemas.microsoft.com/office/drawing/2014/main" id="{8B307500-9286-9A51-BD5B-C9D92900787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4161130"/>
                </p:ext>
              </p:extLst>
            </p:nvPr>
          </p:nvGraphicFramePr>
          <p:xfrm>
            <a:off x="0" y="0"/>
            <a:ext cx="2899128" cy="2736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" name="テキスト ボックス 10">
              <a:extLst>
                <a:ext uri="{FF2B5EF4-FFF2-40B4-BE49-F238E27FC236}">
                  <a16:creationId xmlns:a16="http://schemas.microsoft.com/office/drawing/2014/main" id="{018F4B49-861A-DE4F-9F13-B33EE269AF0D}"/>
                </a:ext>
              </a:extLst>
            </p:cNvPr>
            <p:cNvSpPr txBox="1"/>
            <p:nvPr/>
          </p:nvSpPr>
          <p:spPr>
            <a:xfrm>
              <a:off x="2422877" y="150284"/>
              <a:ext cx="254000" cy="27150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100"/>
                <a:t>a</a:t>
              </a:r>
            </a:p>
          </p:txBody>
        </p:sp>
        <p:sp>
          <p:nvSpPr>
            <p:cNvPr id="9" name="テキスト ボックス 11">
              <a:extLst>
                <a:ext uri="{FF2B5EF4-FFF2-40B4-BE49-F238E27FC236}">
                  <a16:creationId xmlns:a16="http://schemas.microsoft.com/office/drawing/2014/main" id="{1BD96640-8474-64D5-E4F2-AACE76E29E5B}"/>
                </a:ext>
              </a:extLst>
            </p:cNvPr>
            <p:cNvSpPr txBox="1"/>
            <p:nvPr/>
          </p:nvSpPr>
          <p:spPr>
            <a:xfrm>
              <a:off x="1366230" y="618671"/>
              <a:ext cx="247650" cy="27150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100"/>
                <a:t>c</a:t>
              </a:r>
            </a:p>
          </p:txBody>
        </p:sp>
        <p:sp>
          <p:nvSpPr>
            <p:cNvPr id="10" name="テキスト ボックス 12">
              <a:extLst>
                <a:ext uri="{FF2B5EF4-FFF2-40B4-BE49-F238E27FC236}">
                  <a16:creationId xmlns:a16="http://schemas.microsoft.com/office/drawing/2014/main" id="{4FF27611-6F1A-8F79-CF56-F12F82B5C24B}"/>
                </a:ext>
              </a:extLst>
            </p:cNvPr>
            <p:cNvSpPr txBox="1"/>
            <p:nvPr/>
          </p:nvSpPr>
          <p:spPr>
            <a:xfrm>
              <a:off x="1879231" y="412973"/>
              <a:ext cx="234950" cy="27150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100"/>
                <a:t>b</a:t>
              </a:r>
            </a:p>
          </p:txBody>
        </p:sp>
        <p:sp>
          <p:nvSpPr>
            <p:cNvPr id="11" name="テキスト ボックス 13">
              <a:extLst>
                <a:ext uri="{FF2B5EF4-FFF2-40B4-BE49-F238E27FC236}">
                  <a16:creationId xmlns:a16="http://schemas.microsoft.com/office/drawing/2014/main" id="{27B57D30-C811-FFF2-21C3-778D23A2A727}"/>
                </a:ext>
              </a:extLst>
            </p:cNvPr>
            <p:cNvSpPr txBox="1"/>
            <p:nvPr/>
          </p:nvSpPr>
          <p:spPr>
            <a:xfrm>
              <a:off x="848077" y="387993"/>
              <a:ext cx="247650" cy="27150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10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56679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6</TotalTime>
  <Words>198</Words>
  <Application>Microsoft Office PowerPoint</Application>
  <PresentationFormat>ワイド画面</PresentationFormat>
  <Paragraphs>19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郡山 貴子</dc:creator>
  <cp:lastModifiedBy>貴子 郡山</cp:lastModifiedBy>
  <cp:revision>18</cp:revision>
  <dcterms:created xsi:type="dcterms:W3CDTF">2025-12-03T05:44:02Z</dcterms:created>
  <dcterms:modified xsi:type="dcterms:W3CDTF">2026-04-04T02:37:01Z</dcterms:modified>
</cp:coreProperties>
</file>